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419A9-81FF-40F6-AD68-DC6893A657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36161-9E95-4FEE-A8A5-49F2517E6F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C10E2-064E-4C81-976A-53A281BDAF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56D02-5E97-4249-ABB5-35825892B8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28DD0-39FD-4071-8B71-130AF1E9CB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8CA30-0E82-400E-8190-1494D0713E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6233E-4333-4518-97DF-6BC58ED6CA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28710-A9D0-4E0C-A1E5-3652A29822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21B40-F74A-4366-8A88-DFB3F16A71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89EE6-C3FD-4B85-A9B6-516BE88EEA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D4657-5A3B-45DF-8E41-7221100B4B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C8126-E4D5-4E57-92E1-85ECC5C201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B7B075A-F0AA-4848-98D9-A4CC1733181A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900000"/>
            <a:ext cx="6858000" cy="0"/>
          </a:xfrm>
          <a:prstGeom prst="line">
            <a:avLst/>
          </a:prstGeom>
          <a:ln w="57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1187280"/>
            <a:ext cx="6858000" cy="0"/>
          </a:xfrm>
          <a:prstGeom prst="line">
            <a:avLst/>
          </a:prstGeom>
          <a:ln w="572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518080" y="133200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Y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221000" y="1693800"/>
            <a:ext cx="216000" cy="50184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302080" y="133200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Y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941720" y="973080"/>
            <a:ext cx="144720" cy="36036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300640" y="984240"/>
            <a:ext cx="144360" cy="36036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084640" y="75564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73360" y="342108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516640" y="3564000"/>
            <a:ext cx="216000" cy="5047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516640" y="227016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A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69000" y="2270160"/>
            <a:ext cx="21564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LN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557360" y="2268360"/>
            <a:ext cx="216000" cy="5050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K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852640" y="1693800"/>
            <a:ext cx="216000" cy="50184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L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516640" y="4646520"/>
            <a:ext cx="216000" cy="50184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K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573360" y="5869080"/>
            <a:ext cx="216000" cy="5047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R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573360" y="514836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73360" y="4214880"/>
            <a:ext cx="216000" cy="5014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557360" y="4643280"/>
            <a:ext cx="216000" cy="5050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K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773360" y="3421080"/>
            <a:ext cx="215640" cy="5731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RM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557360" y="3456000"/>
            <a:ext cx="216000" cy="5047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L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341360" y="345456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L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516640" y="5869080"/>
            <a:ext cx="216000" cy="5047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N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125360" y="5869080"/>
            <a:ext cx="216000" cy="5047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F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573360" y="716292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R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557360" y="5869080"/>
            <a:ext cx="216000" cy="5047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49360" y="6732720"/>
            <a:ext cx="5759280" cy="0"/>
          </a:xfrm>
          <a:prstGeom prst="line">
            <a:avLst/>
          </a:prstGeom>
          <a:ln w="38160">
            <a:solidFill>
              <a:srgbClr val="80808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141560" y="7162920"/>
            <a:ext cx="21564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F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516640" y="716292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N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573360" y="226836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O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1" name=""/>
          <p:cNvCxnSpPr>
            <a:stCxn id="51" idx="2"/>
            <a:endCxn id="50" idx="0"/>
          </p:cNvCxnSpPr>
          <p:nvPr/>
        </p:nvCxnSpPr>
        <p:spPr>
          <a:xfrm>
            <a:off x="5624640" y="2773440"/>
            <a:ext cx="360" cy="79092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72" name=""/>
          <p:cNvCxnSpPr>
            <a:stCxn id="44" idx="1"/>
            <a:endCxn id="54" idx="3"/>
          </p:cNvCxnSpPr>
          <p:nvPr/>
        </p:nvCxnSpPr>
        <p:spPr>
          <a:xfrm flipH="1">
            <a:off x="3068640" y="1944720"/>
            <a:ext cx="115272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3" name=""/>
          <p:cNvCxnSpPr>
            <a:stCxn id="53" idx="2"/>
            <a:endCxn id="61" idx="0"/>
          </p:cNvCxnSpPr>
          <p:nvPr/>
        </p:nvCxnSpPr>
        <p:spPr>
          <a:xfrm>
            <a:off x="1665360" y="2773440"/>
            <a:ext cx="360" cy="682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4" name=""/>
          <p:cNvCxnSpPr>
            <a:stCxn id="61" idx="2"/>
            <a:endCxn id="59" idx="0"/>
          </p:cNvCxnSpPr>
          <p:nvPr/>
        </p:nvCxnSpPr>
        <p:spPr>
          <a:xfrm>
            <a:off x="1665360" y="3960720"/>
            <a:ext cx="360" cy="682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5" name=""/>
          <p:cNvCxnSpPr>
            <a:stCxn id="64" idx="3"/>
            <a:endCxn id="66" idx="1"/>
          </p:cNvCxnSpPr>
          <p:nvPr/>
        </p:nvCxnSpPr>
        <p:spPr>
          <a:xfrm>
            <a:off x="1341360" y="6121440"/>
            <a:ext cx="21636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76" name=""/>
          <p:cNvCxnSpPr>
            <a:stCxn id="44" idx="3"/>
            <a:endCxn id="52" idx="1"/>
          </p:cNvCxnSpPr>
          <p:nvPr/>
        </p:nvCxnSpPr>
        <p:spPr>
          <a:xfrm>
            <a:off x="4437000" y="1944720"/>
            <a:ext cx="432360" cy="57744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77" name=""/>
          <p:cNvCxnSpPr>
            <a:stCxn id="50" idx="2"/>
            <a:endCxn id="55" idx="0"/>
          </p:cNvCxnSpPr>
          <p:nvPr/>
        </p:nvCxnSpPr>
        <p:spPr>
          <a:xfrm>
            <a:off x="5624640" y="4068720"/>
            <a:ext cx="360" cy="578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8" name=""/>
          <p:cNvCxnSpPr>
            <a:stCxn id="55" idx="2"/>
            <a:endCxn id="63" idx="0"/>
          </p:cNvCxnSpPr>
          <p:nvPr/>
        </p:nvCxnSpPr>
        <p:spPr>
          <a:xfrm>
            <a:off x="5624640" y="5148360"/>
            <a:ext cx="360" cy="72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9" name=""/>
          <p:cNvCxnSpPr>
            <a:stCxn id="64" idx="2"/>
            <a:endCxn id="68" idx="0"/>
          </p:cNvCxnSpPr>
          <p:nvPr/>
        </p:nvCxnSpPr>
        <p:spPr>
          <a:xfrm>
            <a:off x="1233360" y="6373800"/>
            <a:ext cx="16200" cy="78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0" name=""/>
          <p:cNvCxnSpPr>
            <a:stCxn id="52" idx="1"/>
            <a:endCxn id="70" idx="3"/>
          </p:cNvCxnSpPr>
          <p:nvPr/>
        </p:nvCxnSpPr>
        <p:spPr>
          <a:xfrm flipH="1" flipV="1">
            <a:off x="3789360" y="2520000"/>
            <a:ext cx="1080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81" name=""/>
          <p:cNvCxnSpPr>
            <a:stCxn id="70" idx="2"/>
            <a:endCxn id="49" idx="0"/>
          </p:cNvCxnSpPr>
          <p:nvPr/>
        </p:nvCxnSpPr>
        <p:spPr>
          <a:xfrm>
            <a:off x="3681360" y="2771640"/>
            <a:ext cx="360" cy="649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2" name=""/>
          <p:cNvCxnSpPr>
            <a:stCxn id="49" idx="2"/>
            <a:endCxn id="58" idx="0"/>
          </p:cNvCxnSpPr>
          <p:nvPr/>
        </p:nvCxnSpPr>
        <p:spPr>
          <a:xfrm>
            <a:off x="3681360" y="3924360"/>
            <a:ext cx="360" cy="290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3" name=""/>
          <p:cNvCxnSpPr>
            <a:stCxn id="58" idx="2"/>
            <a:endCxn id="57" idx="0"/>
          </p:cNvCxnSpPr>
          <p:nvPr/>
        </p:nvCxnSpPr>
        <p:spPr>
          <a:xfrm>
            <a:off x="3681360" y="4716360"/>
            <a:ext cx="360" cy="432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4" name=""/>
          <p:cNvCxnSpPr>
            <a:stCxn id="57" idx="2"/>
            <a:endCxn id="56" idx="0"/>
          </p:cNvCxnSpPr>
          <p:nvPr/>
        </p:nvCxnSpPr>
        <p:spPr>
          <a:xfrm>
            <a:off x="3681360" y="5651640"/>
            <a:ext cx="360" cy="2178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5" name=""/>
          <p:cNvCxnSpPr>
            <a:stCxn id="52" idx="3"/>
            <a:endCxn id="51" idx="1"/>
          </p:cNvCxnSpPr>
          <p:nvPr/>
        </p:nvCxnSpPr>
        <p:spPr>
          <a:xfrm>
            <a:off x="5084640" y="2521800"/>
            <a:ext cx="43236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86" name=""/>
          <p:cNvCxnSpPr>
            <a:stCxn id="43" idx="2"/>
            <a:endCxn id="51" idx="0"/>
          </p:cNvCxnSpPr>
          <p:nvPr/>
        </p:nvCxnSpPr>
        <p:spPr>
          <a:xfrm flipH="1">
            <a:off x="5624640" y="1835280"/>
            <a:ext cx="1800" cy="435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7" name=""/>
          <p:cNvSpPr/>
          <p:nvPr/>
        </p:nvSpPr>
        <p:spPr>
          <a:xfrm rot="16200000">
            <a:off x="3067560" y="5509440"/>
            <a:ext cx="362160" cy="5113080"/>
          </a:xfrm>
          <a:custGeom>
            <a:avLst/>
            <a:gdLst>
              <a:gd name="textAreaLeft" fmla="*/ 231480 w 362160"/>
              <a:gd name="textAreaRight" fmla="*/ 362160 w 362160"/>
              <a:gd name="textAreaTop" fmla="*/ 133200 h 5113080"/>
              <a:gd name="textAreaBottom" fmla="*/ 4979880 h 51130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951280" y="8317080"/>
            <a:ext cx="1319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Transcrip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9" name=""/>
          <p:cNvCxnSpPr>
            <a:stCxn id="56" idx="2"/>
            <a:endCxn id="65" idx="0"/>
          </p:cNvCxnSpPr>
          <p:nvPr/>
        </p:nvCxnSpPr>
        <p:spPr>
          <a:xfrm>
            <a:off x="3681360" y="6373800"/>
            <a:ext cx="360" cy="78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0" name=""/>
          <p:cNvCxnSpPr>
            <a:stCxn id="63" idx="2"/>
            <a:endCxn id="69" idx="0"/>
          </p:cNvCxnSpPr>
          <p:nvPr/>
        </p:nvCxnSpPr>
        <p:spPr>
          <a:xfrm>
            <a:off x="5624640" y="6373800"/>
            <a:ext cx="360" cy="78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1" name=""/>
          <p:cNvSpPr/>
          <p:nvPr/>
        </p:nvSpPr>
        <p:spPr>
          <a:xfrm>
            <a:off x="2349360" y="2451240"/>
            <a:ext cx="144720" cy="144360"/>
          </a:xfrm>
          <a:prstGeom prst="ellipse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134800" y="2627280"/>
            <a:ext cx="51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3" name=""/>
          <p:cNvCxnSpPr>
            <a:stCxn id="54" idx="1"/>
            <a:endCxn id="91" idx="0"/>
          </p:cNvCxnSpPr>
          <p:nvPr/>
        </p:nvCxnSpPr>
        <p:spPr>
          <a:xfrm flipH="1">
            <a:off x="2421720" y="1944720"/>
            <a:ext cx="431280" cy="506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4" name=""/>
          <p:cNvCxnSpPr>
            <a:stCxn id="91" idx="2"/>
            <a:endCxn id="53" idx="3"/>
          </p:cNvCxnSpPr>
          <p:nvPr/>
        </p:nvCxnSpPr>
        <p:spPr>
          <a:xfrm flipH="1" flipV="1">
            <a:off x="1773360" y="2520720"/>
            <a:ext cx="576360" cy="2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5" name=""/>
          <p:cNvCxnSpPr>
            <a:stCxn id="91" idx="6"/>
            <a:endCxn id="49" idx="1"/>
          </p:cNvCxnSpPr>
          <p:nvPr/>
        </p:nvCxnSpPr>
        <p:spPr>
          <a:xfrm>
            <a:off x="2494080" y="2523240"/>
            <a:ext cx="1079640" cy="1149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6" name=""/>
          <p:cNvSpPr/>
          <p:nvPr/>
        </p:nvSpPr>
        <p:spPr>
          <a:xfrm>
            <a:off x="1557360" y="586728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573360" y="3421080"/>
            <a:ext cx="216000" cy="5014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557360" y="5865840"/>
            <a:ext cx="216000" cy="5032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FKBI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013360" y="305928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K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92280" y="7093080"/>
            <a:ext cx="215640" cy="64764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0000"/>
                </a:solidFill>
                <a:latin typeface="Arial"/>
              </a:rPr>
              <a:t>SMARC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1" name=""/>
          <p:cNvCxnSpPr>
            <a:stCxn id="59" idx="2"/>
          </p:cNvCxnSpPr>
          <p:nvPr/>
        </p:nvCxnSpPr>
        <p:spPr>
          <a:xfrm>
            <a:off x="1665360" y="5148360"/>
            <a:ext cx="720" cy="675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2" name=""/>
          <p:cNvSpPr/>
          <p:nvPr/>
        </p:nvSpPr>
        <p:spPr>
          <a:xfrm>
            <a:off x="1272240" y="150840"/>
            <a:ext cx="448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 CELL RECEPTOR SIGNALLING PATHW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28 CuadroTexto"/>
          <p:cNvSpPr/>
          <p:nvPr/>
        </p:nvSpPr>
        <p:spPr>
          <a:xfrm>
            <a:off x="5663520" y="867564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4" name=""/>
          <p:cNvCxnSpPr>
            <a:stCxn id="100" idx="3"/>
            <a:endCxn id="68" idx="1"/>
          </p:cNvCxnSpPr>
          <p:nvPr/>
        </p:nvCxnSpPr>
        <p:spPr>
          <a:xfrm flipV="1">
            <a:off x="907920" y="7414560"/>
            <a:ext cx="234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05" name=""/>
          <p:cNvCxnSpPr>
            <a:stCxn id="91" idx="6"/>
            <a:endCxn id="99" idx="1"/>
          </p:cNvCxnSpPr>
          <p:nvPr/>
        </p:nvCxnSpPr>
        <p:spPr>
          <a:xfrm>
            <a:off x="2494080" y="2523240"/>
            <a:ext cx="2519640" cy="787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6" name=""/>
          <p:cNvCxnSpPr>
            <a:stCxn id="51" idx="2"/>
            <a:endCxn id="99" idx="3"/>
          </p:cNvCxnSpPr>
          <p:nvPr/>
        </p:nvCxnSpPr>
        <p:spPr>
          <a:xfrm flipH="1">
            <a:off x="5229360" y="2773440"/>
            <a:ext cx="395640" cy="5374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107" name=""/>
          <p:cNvCxnSpPr>
            <a:stCxn id="50" idx="1"/>
            <a:endCxn id="99" idx="3"/>
          </p:cNvCxnSpPr>
          <p:nvPr/>
        </p:nvCxnSpPr>
        <p:spPr>
          <a:xfrm flipH="1" flipV="1">
            <a:off x="5229360" y="3310560"/>
            <a:ext cx="287640" cy="50616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108" name=""/>
          <p:cNvSpPr/>
          <p:nvPr/>
        </p:nvSpPr>
        <p:spPr>
          <a:xfrm>
            <a:off x="3573360" y="3419640"/>
            <a:ext cx="216000" cy="5014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557360" y="586440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FKBI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013360" y="305928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PRK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573360" y="3419640"/>
            <a:ext cx="216000" cy="5014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R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557360" y="586440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NFKBI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692280" y="7093080"/>
            <a:ext cx="215640" cy="64764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SMARC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013360" y="305928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PRK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573360" y="3419640"/>
            <a:ext cx="216000" cy="50148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RA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557360" y="5864400"/>
            <a:ext cx="216000" cy="502920"/>
          </a:xfrm>
          <a:prstGeom prst="rect">
            <a:avLst/>
          </a:prstGeom>
          <a:solidFill>
            <a:srgbClr val="eaeae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0000"/>
                </a:solidFill>
                <a:latin typeface="Arial"/>
              </a:rPr>
              <a:t>NFKBI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07T11:10:57Z</dcterms:created>
  <dc:creator>huphm</dc:creator>
  <dc:description/>
  <dc:language>en-US</dc:language>
  <cp:lastModifiedBy>huphm</cp:lastModifiedBy>
  <dcterms:modified xsi:type="dcterms:W3CDTF">2012-03-23T15:03:43Z</dcterms:modified>
  <cp:revision>8</cp:revision>
  <dc:subject/>
  <dc:title>Diapositiva 1</dc:title>
</cp:coreProperties>
</file>